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54" d="100"/>
          <a:sy n="154" d="100"/>
        </p:scale>
        <p:origin x="-678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3181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886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9989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9150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6973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8240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270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2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1734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2969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6454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C163F-2B7E-4CC0-99E9-A1B2D0AD8455}" type="datetimeFigureOut">
              <a:rPr lang="fr-FR" smtClean="0"/>
              <a:t>02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DB6B4-1ABD-42F6-B09E-2571BBCA7D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078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736000"/>
              </p:ext>
            </p:extLst>
          </p:nvPr>
        </p:nvGraphicFramePr>
        <p:xfrm>
          <a:off x="548680" y="2018953"/>
          <a:ext cx="5904656" cy="7543812"/>
        </p:xfrm>
        <a:graphic>
          <a:graphicData uri="http://schemas.openxmlformats.org/drawingml/2006/table">
            <a:tbl>
              <a:tblPr/>
              <a:tblGrid>
                <a:gridCol w="1359726"/>
                <a:gridCol w="3293363"/>
                <a:gridCol w="635717"/>
                <a:gridCol w="615850"/>
              </a:tblGrid>
              <a:tr h="121639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S2RLP-DLX5 &amp; BMP4</a:t>
                      </a:r>
                    </a:p>
                  </a:txBody>
                  <a:tcPr marL="5535" marR="5535" marT="553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27721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rm</a:t>
                      </a:r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fr-FR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me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mbers input overlap gene ID 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 term ID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ad morphogenesi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6032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7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ody morphogenesi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1017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2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tramolecular oxidoreductase activity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DIA5; EIF2B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1686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5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ad development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6032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7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late development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MPR1A; DLX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6002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2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gulation of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NKS; NCOA2; LRRFIP1; ARHGAP31; ZFHX4; PDIA5; EIF2B2; BMPR1A; CDK2; ZNF552; LBH; 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1922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3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ucleobase-containing compound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NKS; NCOA2; LRRFIP1; ARHGAP31; ZFHX4; PDIA5; EIF2B2; BMPR1A; CDK2; ZNF552; LBH; 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0613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9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terocycle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NKS; NCOA2; LRRFIP1; ARHGAP31; ZFHX4; PDIA5; EIF2B2; BMPR1A; CDK2; ZNF552; LBH; 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648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1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llular aromatic compound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NKS; NCOA2; LRRFIP1; ARHGAP31; ZFHX4; PDIA5; EIF2B2; BMPR1A; CDK2; ZNF552; LBH; 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0672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2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rganic cyclic compound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NKS; NCOA2; LRRFIP1; ARHGAP31; ZFHX4; PDIA5; EIF2B2; BMPR1A; CDK2; ZNF552; LBH; 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190136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71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6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llular nitrogen compound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NKS; NCOA2; LRRFIP1; ARHGAP31; ZFHX4; PDIA5; EIF2B2; BMPR1A; CDK2; ZNF552; LBH; DLX5; SSBP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3464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72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721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S2RLP-RUNX2 &amp; BMP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27721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rm nam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mbers input overlap gene ID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 Term ID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ssification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MA7A; WNT5A; IBSP; SMOC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0150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9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stone modification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COR1; KDM3A; BRCC3; SATB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1657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6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gnal transduction by phosphorylation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P2A; ANGPT1; SEMA7A; WNT5A; CREB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230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9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llular developmental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P2A; KDM3A; STMN2; SEMA7A; CREB1; RCOR1; SATB1; WNT5A; ANGPT1; IBSP; SMOC1; HAS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886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2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tokine production involved in immune respons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NT5A; SEMA7A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02367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3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gulation of cellular component siz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NT5A; SEMA7A; CREB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3253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2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ngle-organism biosynthet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GPT1; SCD; CREB1; AK4; KDM3A; CSGALNACT2; HAS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471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61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ystem development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P2A; STMN2; SEMA7A; CREB1; AK4; RCOR1; SATB1; WNT5A; ANGPT1; IBSP; SMOC1; HAS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873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62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matopoietic or lymphoid organ development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NT5A; ANGPT1; RCOR1; SATB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853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64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6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rganonitrogen compound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P2A; SLC6A6; AK4; TIAM2; RASA4; WNT5A; ANGPT1; CSGALNACT2; HAS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190156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96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7721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S2RLP-RUNX2 &amp; MS2RLP-DLX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27721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rm nam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mbers input overlap gene ID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 term ID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0180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tion binding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US; DHTKD1; ME3; MID1; BRPF3; SRSF7; THBS3; GLI2; PFKM; MIPEP; ZBTB34; AMY2A; ENPP1; IMPA2; EFHC1; THNSL2; PLD6; RPS6KA6; ZNF671; BNC2; PLSCR1; PPP3CA; PDE4B; EWSR1; MLPH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316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191E-0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dentical protein binding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LD6; FUS; SNX9; PFKM; ENPP1; IMPA2; FLT3LG; LUC7L; EWSR1; MID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280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8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llular carbohydrate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HTKD1; IMPA2; PYGB; PFKM; ENPP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426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5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ngle-organism ca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SP17L2; PLD6; PLSCR1; SNX9; PFKM; ENPP1; DHX38; IMPA2; PYGB; DHTKD1; CRMP1; PDE4B; THNSL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471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1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abecula formation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GFBR3; THBS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6034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3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state gland morphogenesi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I2; TNC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6051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7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state gland epithelium morphogenesi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I2; TNC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6074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4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63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abecula morphogenesi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GFBR3; THBS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6138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46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ion binding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GFBR3; THBS3; HIPK3; THRAP3; AMY2A; MTHFD1; SNX9; PFKM; RPS6KA6; ENPP1; DHX38; PYGB; DHTKD1; PDE4B; THNSL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316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5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rganic substance ca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SP17L2; PLD6; AMY2A; THRAP3; PLSCR1; SNX9; PFKM; ENPP1; DHX38; IMPA2; PYGB; DHTKD1; CRMP1; PDE4B; THNSL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190157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7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ssue development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GFBR3; RPS6KA6; BNC2; THBS3; ENPP1; GLI2; TNC; PPP3CA; LUC7L; MLPH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0988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76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ration of precursor metabolites and energy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HTKD1; PFKM; PYGB; ME3; ENPP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0609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82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0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velopmental growth involved in morphogenesi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BS3; TNC; BNC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6056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87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69"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mall molecule metabolic proces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SP17L2; PLD6; AMY2A; MTHFD1; PLSCR1; SNX9; PFKM; SLC25A37; ENPP1; DHX38; IMPA2; PYGB; ME3; GGT5; CRMP1; PDE4B; THNSL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O:004428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88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999" y="302024"/>
            <a:ext cx="1360932" cy="1371791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154450" y="21623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  <a:lvl6pPr>
              <a:defRPr/>
            </a:lvl6pPr>
            <a:lvl7pPr>
              <a:defRPr/>
            </a:lvl7pPr>
            <a:lvl8pPr>
              <a:defRPr/>
            </a:lvl8pPr>
            <a:lvl9pPr>
              <a:defRPr/>
            </a:lvl9pPr>
          </a:lstStyle>
          <a:p>
            <a:r>
              <a:rPr lang="fr-FR" dirty="0"/>
              <a:t>A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158578" y="195015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  <a:lvl6pPr>
              <a:defRPr/>
            </a:lvl6pPr>
            <a:lvl7pPr>
              <a:defRPr/>
            </a:lvl7pPr>
            <a:lvl8pPr>
              <a:defRPr/>
            </a:lvl8pPr>
            <a:lvl9pPr>
              <a:defRPr/>
            </a:lvl9pPr>
          </a:lstStyle>
          <a:p>
            <a:r>
              <a:rPr lang="fr-FR" dirty="0" smtClean="0"/>
              <a:t>B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850985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749</Words>
  <Application>Microsoft Office PowerPoint</Application>
  <PresentationFormat>Format A4 (210 x 297 mm)</PresentationFormat>
  <Paragraphs>15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5273-2014-AP</dc:creator>
  <cp:lastModifiedBy>5273-2014-AP</cp:lastModifiedBy>
  <cp:revision>9</cp:revision>
  <cp:lastPrinted>2015-06-16T16:34:41Z</cp:lastPrinted>
  <dcterms:created xsi:type="dcterms:W3CDTF">2015-06-16T16:07:17Z</dcterms:created>
  <dcterms:modified xsi:type="dcterms:W3CDTF">2015-09-02T09:10:39Z</dcterms:modified>
</cp:coreProperties>
</file>